
<file path=[Content_Types].xml><?xml version="1.0" encoding="utf-8"?>
<Types xmlns="http://schemas.openxmlformats.org/package/2006/content-types"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0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ABAB"/>
    <a:srgbClr val="767171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3"/>
  </p:normalViewPr>
  <p:slideViewPr>
    <p:cSldViewPr snapToGrid="0" snapToObjects="1">
      <p:cViewPr varScale="1">
        <p:scale>
          <a:sx n="116" d="100"/>
          <a:sy n="116" d="100"/>
        </p:scale>
        <p:origin x="4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E35D04-F06A-1746-8CEE-8B514FCBA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0007155-1C1F-FD4D-B4D2-88DCB143EB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487C01C-229C-414E-BB77-F4BB8844B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1D5AC3-26DA-3745-88D3-5C87D9F99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22FC800-B5D9-2743-B590-E4713FACD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3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81392E-03BE-D54E-B749-3C4E7461C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D576FF8-30F6-C440-9853-E605DED799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8F5B0D6-D43F-704F-94A6-8A70AC579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34B5BC8-9E07-8744-83F2-236B0A802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522CA05-2388-1740-A7AE-468E1623E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3409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F7AE445-D9F6-7243-9095-6BDA90AD3D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B23E3DE-CBE3-6E4F-BF8E-2BFE8588FF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7BA967F-712B-694C-9EA9-E7CDCBA26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B2B580F-46F6-714A-BDA1-0F58CF0E8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6D71A2C-9DF3-BD47-9C08-52758D8C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12652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220FA2-F925-D84A-9AC6-2BC0BD4EF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F573D4-D4C8-8742-9355-7033A8940C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9166C5C-C802-A44B-859B-CDA4F087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4D8038-C761-A745-9F17-33083EF45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7C70B0-67AB-594C-8A14-78E379381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6880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845248-61F4-F84D-B175-E9CC92FAA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8F3156A-8506-B148-96AC-D5AD371F0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9B4EAD2-41F3-FE4F-BBA5-AA04DA806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1A0AEC0-0F69-C440-87E6-443B57CFD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792747A-5AF2-944D-9769-73005DE98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35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F5E525-CB95-2648-B125-26332B956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D689BEE-011D-3540-9EC0-A98897287C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637126C-C0C6-CE44-839E-3A0D6FA0A1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589F00B8-EC86-774E-947D-7E9E6540C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5B072FB-FD12-1F42-9CE0-BC6756019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5D7C1E8-437C-534C-9897-4092352C2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6744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4C5A4F-F029-544B-929D-E004DDC89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30664DA-0241-534D-A280-5F294ECF3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9A655CB-0C03-0348-8BE0-8DFDC4790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EF61E243-C31A-1E43-8220-E794EF8CD1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7613710-7A82-A844-A106-3BA599CF30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CF70AB4D-958D-E145-9CEB-D79C5943D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918BCF4-8EE6-B542-81D8-6EB8FA950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C4123B0C-76A1-BE4F-A9D7-56A1A4567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80763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277EB9-F9C1-F349-829F-987A849E7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CC56CB96-61A7-DE41-9469-6A893C3A1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B6EEF1A5-5B70-114E-9D6D-6A68E0030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2FE25BEE-A896-5D49-A1DA-37E12B424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48366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7F90CEC0-345B-6246-978E-1A56D765D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2F61B865-24C9-074B-816A-A568995C1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1A4FDBA-79EE-8749-AA73-25DF8CFA0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974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EB9312-CCF8-454E-B09D-3C7E970F6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91D2C49-CDBF-2C47-9B75-B6487A2101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1EC0A8D-0BEF-5143-8351-302124FD4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61FFFD4-50C0-8149-89BB-C8F16CA60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799687F-24F1-3646-B97B-D7951F2E4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EBFAD89-B06B-E34A-8070-A4CFBA4E6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3311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360A32-557E-7A44-813A-354941B06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4289B997-F045-A84D-B010-49CF848118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8127117-70E7-634B-860E-3DE3B5D754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276A3B5-863E-CE46-9C53-E32F3F0D2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99F04A1-4A15-A645-916A-41E9C3D57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CA0356B-3932-A247-9CBA-A4C8BFBF2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5633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492E6718-E617-D34F-B325-9E2749742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7CCD09B-D538-4B4B-B775-602D7C5113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7A96B73-39C7-CE4D-8EFC-1609C264EB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5FE97-E3C9-114B-91DE-5F7CDC73DF5A}" type="datetimeFigureOut">
              <a:rPr lang="pt-BR" smtClean="0"/>
              <a:t>30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A3864C4-E135-C04F-969E-1D08B0A1C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59420BB-5753-0544-B77C-91F0CB8C30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54046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jp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Agrupar 7">
            <a:extLst>
              <a:ext uri="{FF2B5EF4-FFF2-40B4-BE49-F238E27FC236}">
                <a16:creationId xmlns:a16="http://schemas.microsoft.com/office/drawing/2014/main" id="{24C3073B-B2A2-A74F-B410-1222DB54A6D7}"/>
              </a:ext>
            </a:extLst>
          </p:cNvPr>
          <p:cNvGrpSpPr/>
          <p:nvPr/>
        </p:nvGrpSpPr>
        <p:grpSpPr>
          <a:xfrm>
            <a:off x="5367290" y="1700281"/>
            <a:ext cx="5879592" cy="4471469"/>
            <a:chOff x="2914649" y="628651"/>
            <a:chExt cx="6229349" cy="4961599"/>
          </a:xfrm>
        </p:grpSpPr>
        <p:pic>
          <p:nvPicPr>
            <p:cNvPr id="9" name="Imagem 8" descr="Uma imagem contendo monitor, água, preto, tela&#10;&#10;Descrição gerada automaticamente">
              <a:extLst>
                <a:ext uri="{FF2B5EF4-FFF2-40B4-BE49-F238E27FC236}">
                  <a16:creationId xmlns:a16="http://schemas.microsoft.com/office/drawing/2014/main" id="{5FACD3B3-C451-C743-A328-1E011B2E30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2104" t="5522" r="7553" b="9153"/>
            <a:stretch/>
          </p:blipFill>
          <p:spPr>
            <a:xfrm>
              <a:off x="2914649" y="628651"/>
              <a:ext cx="6229349" cy="4961599"/>
            </a:xfrm>
            <a:prstGeom prst="rect">
              <a:avLst/>
            </a:prstGeom>
          </p:spPr>
        </p:pic>
        <p:sp>
          <p:nvSpPr>
            <p:cNvPr id="10" name="CaixaDeTexto 9">
              <a:extLst>
                <a:ext uri="{FF2B5EF4-FFF2-40B4-BE49-F238E27FC236}">
                  <a16:creationId xmlns:a16="http://schemas.microsoft.com/office/drawing/2014/main" id="{33C97438-A2D0-6544-B75E-AF119A412606}"/>
                </a:ext>
              </a:extLst>
            </p:cNvPr>
            <p:cNvSpPr txBox="1"/>
            <p:nvPr/>
          </p:nvSpPr>
          <p:spPr>
            <a:xfrm>
              <a:off x="3950154" y="3393525"/>
              <a:ext cx="1738992" cy="409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i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Inspiration</a:t>
              </a:r>
            </a:p>
          </p:txBody>
        </p:sp>
        <p:sp>
          <p:nvSpPr>
            <p:cNvPr id="12" name="CaixaDeTexto 11">
              <a:extLst>
                <a:ext uri="{FF2B5EF4-FFF2-40B4-BE49-F238E27FC236}">
                  <a16:creationId xmlns:a16="http://schemas.microsoft.com/office/drawing/2014/main" id="{063F9446-28D6-3C44-9C6D-6510633EAF7C}"/>
                </a:ext>
              </a:extLst>
            </p:cNvPr>
            <p:cNvSpPr txBox="1"/>
            <p:nvPr/>
          </p:nvSpPr>
          <p:spPr>
            <a:xfrm>
              <a:off x="6810721" y="4525501"/>
              <a:ext cx="2039886" cy="5122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2400" b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IVCCI = 64%</a:t>
              </a:r>
            </a:p>
          </p:txBody>
        </p:sp>
        <p:sp>
          <p:nvSpPr>
            <p:cNvPr id="11" name="CaixaDeTexto 10">
              <a:extLst>
                <a:ext uri="{FF2B5EF4-FFF2-40B4-BE49-F238E27FC236}">
                  <a16:creationId xmlns:a16="http://schemas.microsoft.com/office/drawing/2014/main" id="{F32C7D0E-10C1-574D-AEFF-271BD3F4A8BB}"/>
                </a:ext>
              </a:extLst>
            </p:cNvPr>
            <p:cNvSpPr txBox="1"/>
            <p:nvPr/>
          </p:nvSpPr>
          <p:spPr>
            <a:xfrm>
              <a:off x="6810721" y="4115686"/>
              <a:ext cx="1400175" cy="409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i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Expiration</a:t>
              </a:r>
            </a:p>
          </p:txBody>
        </p:sp>
      </p:grpSp>
      <p:sp>
        <p:nvSpPr>
          <p:cNvPr id="16" name="ZoneTexte 15"/>
          <p:cNvSpPr txBox="1"/>
          <p:nvPr/>
        </p:nvSpPr>
        <p:spPr>
          <a:xfrm>
            <a:off x="879064" y="450580"/>
            <a:ext cx="2263477" cy="52322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Profile C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ideo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ixaDeTexto 11">
            <a:extLst>
              <a:ext uri="{FF2B5EF4-FFF2-40B4-BE49-F238E27FC236}">
                <a16:creationId xmlns:a16="http://schemas.microsoft.com/office/drawing/2014/main" id="{A38519EB-8EBE-E54E-A63E-D3DA137FDB3E}"/>
              </a:ext>
            </a:extLst>
          </p:cNvPr>
          <p:cNvSpPr txBox="1"/>
          <p:nvPr/>
        </p:nvSpPr>
        <p:spPr>
          <a:xfrm>
            <a:off x="8057895" y="3164120"/>
            <a:ext cx="2102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Subcostal view</a:t>
            </a:r>
          </a:p>
        </p:txBody>
      </p:sp>
      <p:grpSp>
        <p:nvGrpSpPr>
          <p:cNvPr id="14" name="Groupe 13"/>
          <p:cNvGrpSpPr/>
          <p:nvPr/>
        </p:nvGrpSpPr>
        <p:grpSpPr>
          <a:xfrm>
            <a:off x="5397528" y="1299055"/>
            <a:ext cx="5900569" cy="430887"/>
            <a:chOff x="6049094" y="906351"/>
            <a:chExt cx="5900569" cy="430887"/>
          </a:xfrm>
        </p:grpSpPr>
        <p:sp>
          <p:nvSpPr>
            <p:cNvPr id="17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6049094" y="906351"/>
              <a:ext cx="5900569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r>
                <a:rPr lang="pt-BR" sz="2200" dirty="0"/>
                <a:t>Inferior veina cava collapsibillity                  positive</a:t>
              </a:r>
            </a:p>
          </p:txBody>
        </p:sp>
        <p:cxnSp>
          <p:nvCxnSpPr>
            <p:cNvPr id="18" name="Connecteur droit avec flèche 17"/>
            <p:cNvCxnSpPr/>
            <p:nvPr/>
          </p:nvCxnSpPr>
          <p:spPr>
            <a:xfrm flipV="1">
              <a:off x="9814221" y="1152939"/>
              <a:ext cx="9144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CaixaDeTexto 16">
            <a:extLst>
              <a:ext uri="{FF2B5EF4-FFF2-40B4-BE49-F238E27FC236}">
                <a16:creationId xmlns:a16="http://schemas.microsoft.com/office/drawing/2014/main" id="{0235FCAF-E083-C242-9511-C06FFFFC5323}"/>
              </a:ext>
            </a:extLst>
          </p:cNvPr>
          <p:cNvSpPr txBox="1"/>
          <p:nvPr/>
        </p:nvSpPr>
        <p:spPr>
          <a:xfrm>
            <a:off x="972679" y="2994910"/>
            <a:ext cx="544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Rib</a:t>
            </a:r>
          </a:p>
        </p:txBody>
      </p:sp>
      <p:cxnSp>
        <p:nvCxnSpPr>
          <p:cNvPr id="21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 flipV="1">
            <a:off x="2298699" y="3567327"/>
            <a:ext cx="940425" cy="360692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ixaDeTexto 22">
            <a:extLst>
              <a:ext uri="{FF2B5EF4-FFF2-40B4-BE49-F238E27FC236}">
                <a16:creationId xmlns:a16="http://schemas.microsoft.com/office/drawing/2014/main" id="{E1E1D95E-4F22-9948-97DF-38D7EBD32C16}"/>
              </a:ext>
            </a:extLst>
          </p:cNvPr>
          <p:cNvSpPr txBox="1"/>
          <p:nvPr/>
        </p:nvSpPr>
        <p:spPr>
          <a:xfrm>
            <a:off x="3121958" y="3735896"/>
            <a:ext cx="11597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dirty="0">
                <a:solidFill>
                  <a:schemeClr val="bg1"/>
                </a:solidFill>
              </a:rPr>
              <a:t>B-lines</a:t>
            </a:r>
          </a:p>
        </p:txBody>
      </p:sp>
      <p:sp>
        <p:nvSpPr>
          <p:cNvPr id="23" name="CaixaDeTexto 23">
            <a:extLst>
              <a:ext uri="{FF2B5EF4-FFF2-40B4-BE49-F238E27FC236}">
                <a16:creationId xmlns:a16="http://schemas.microsoft.com/office/drawing/2014/main" id="{9351AB2E-2DE7-774D-A8CD-C7C77A6501F2}"/>
              </a:ext>
            </a:extLst>
          </p:cNvPr>
          <p:cNvSpPr txBox="1"/>
          <p:nvPr/>
        </p:nvSpPr>
        <p:spPr>
          <a:xfrm>
            <a:off x="3142541" y="5794421"/>
            <a:ext cx="181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Anterior view</a:t>
            </a:r>
          </a:p>
        </p:txBody>
      </p:sp>
      <p:sp>
        <p:nvSpPr>
          <p:cNvPr id="25" name="CaixaDeTexto 16">
            <a:extLst>
              <a:ext uri="{FF2B5EF4-FFF2-40B4-BE49-F238E27FC236}">
                <a16:creationId xmlns:a16="http://schemas.microsoft.com/office/drawing/2014/main" id="{0235FCAF-E083-C242-9511-C06FFFFC5323}"/>
              </a:ext>
            </a:extLst>
          </p:cNvPr>
          <p:cNvSpPr txBox="1"/>
          <p:nvPr/>
        </p:nvSpPr>
        <p:spPr>
          <a:xfrm>
            <a:off x="4196264" y="2978347"/>
            <a:ext cx="544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Rib</a:t>
            </a:r>
          </a:p>
        </p:txBody>
      </p:sp>
      <p:cxnSp>
        <p:nvCxnSpPr>
          <p:cNvPr id="26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>
            <a:off x="2962166" y="3922742"/>
            <a:ext cx="285562" cy="1386532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>
            <a:off x="2519748" y="3918665"/>
            <a:ext cx="727980" cy="653133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5" name="Groupe 34"/>
          <p:cNvGrpSpPr/>
          <p:nvPr/>
        </p:nvGrpSpPr>
        <p:grpSpPr>
          <a:xfrm>
            <a:off x="872394" y="1265580"/>
            <a:ext cx="3898539" cy="430887"/>
            <a:chOff x="1024794" y="901809"/>
            <a:chExt cx="3898539" cy="430887"/>
          </a:xfrm>
        </p:grpSpPr>
        <p:sp>
          <p:nvSpPr>
            <p:cNvPr id="36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1024794" y="901809"/>
              <a:ext cx="3898539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pt-BR" sz="2200" dirty="0"/>
                <a:t>Lung Ultrasound               B-lines</a:t>
              </a:r>
            </a:p>
          </p:txBody>
        </p:sp>
        <p:cxnSp>
          <p:nvCxnSpPr>
            <p:cNvPr id="37" name="Connecteur droit avec flèche 36"/>
            <p:cNvCxnSpPr/>
            <p:nvPr/>
          </p:nvCxnSpPr>
          <p:spPr>
            <a:xfrm flipV="1">
              <a:off x="3083762" y="1143000"/>
              <a:ext cx="82296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4" name="Mídia Online 2" descr="13.04.45 horas __[0000195].mp4">
            <a:hlinkClick r:id="" action="ppaction://media"/>
            <a:extLst>
              <a:ext uri="{FF2B5EF4-FFF2-40B4-BE49-F238E27FC236}">
                <a16:creationId xmlns:a16="http://schemas.microsoft.com/office/drawing/2014/main" id="{8795F036-EF9F-F845-8685-1A4C21951A3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7"/>
          <a:srcRect l="31818" t="20218" r="24753" b="26965"/>
          <a:stretch/>
        </p:blipFill>
        <p:spPr>
          <a:xfrm>
            <a:off x="7041037" y="1724272"/>
            <a:ext cx="2892217" cy="2560320"/>
          </a:xfrm>
          <a:prstGeom prst="rect">
            <a:avLst/>
          </a:prstGeom>
          <a:ln>
            <a:solidFill>
              <a:schemeClr val="accent5">
                <a:lumMod val="40000"/>
                <a:lumOff val="60000"/>
              </a:schemeClr>
            </a:solidFill>
          </a:ln>
        </p:spPr>
      </p:pic>
      <p:sp>
        <p:nvSpPr>
          <p:cNvPr id="28" name="CaixaDeTexto 11">
            <a:extLst>
              <a:ext uri="{FF2B5EF4-FFF2-40B4-BE49-F238E27FC236}">
                <a16:creationId xmlns:a16="http://schemas.microsoft.com/office/drawing/2014/main" id="{A38519EB-8EBE-E54E-A63E-D3DA137FDB3E}"/>
              </a:ext>
            </a:extLst>
          </p:cNvPr>
          <p:cNvSpPr txBox="1"/>
          <p:nvPr/>
        </p:nvSpPr>
        <p:spPr>
          <a:xfrm>
            <a:off x="8407836" y="3907517"/>
            <a:ext cx="16389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600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Subcostal view</a:t>
            </a:r>
          </a:p>
        </p:txBody>
      </p:sp>
      <p:sp>
        <p:nvSpPr>
          <p:cNvPr id="29" name="CaixaDeTexto 4">
            <a:extLst>
              <a:ext uri="{FF2B5EF4-FFF2-40B4-BE49-F238E27FC236}">
                <a16:creationId xmlns:a16="http://schemas.microsoft.com/office/drawing/2014/main" id="{9E1503CC-ACF2-E049-AE68-C8EE9B143EFE}"/>
              </a:ext>
            </a:extLst>
          </p:cNvPr>
          <p:cNvSpPr txBox="1"/>
          <p:nvPr/>
        </p:nvSpPr>
        <p:spPr>
          <a:xfrm>
            <a:off x="7421569" y="1826644"/>
            <a:ext cx="943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Liver</a:t>
            </a:r>
          </a:p>
        </p:txBody>
      </p:sp>
      <p:sp>
        <p:nvSpPr>
          <p:cNvPr id="30" name="CaixaDeTexto 3">
            <a:extLst>
              <a:ext uri="{FF2B5EF4-FFF2-40B4-BE49-F238E27FC236}">
                <a16:creationId xmlns:a16="http://schemas.microsoft.com/office/drawing/2014/main" id="{CFDE78E7-DA3F-DB4A-A13B-375661A86079}"/>
              </a:ext>
            </a:extLst>
          </p:cNvPr>
          <p:cNvSpPr txBox="1"/>
          <p:nvPr/>
        </p:nvSpPr>
        <p:spPr>
          <a:xfrm>
            <a:off x="8084117" y="3224702"/>
            <a:ext cx="8060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>
                <a:solidFill>
                  <a:schemeClr val="bg1"/>
                </a:solidFill>
              </a:rPr>
              <a:t>Right atrium</a:t>
            </a:r>
          </a:p>
        </p:txBody>
      </p:sp>
      <p:sp>
        <p:nvSpPr>
          <p:cNvPr id="34" name="CaixaDeTexto 2">
            <a:extLst>
              <a:ext uri="{FF2B5EF4-FFF2-40B4-BE49-F238E27FC236}">
                <a16:creationId xmlns:a16="http://schemas.microsoft.com/office/drawing/2014/main" id="{9DBD0832-3885-CF4F-A0C6-5A011F4CB8BD}"/>
              </a:ext>
            </a:extLst>
          </p:cNvPr>
          <p:cNvSpPr txBox="1"/>
          <p:nvPr/>
        </p:nvSpPr>
        <p:spPr>
          <a:xfrm>
            <a:off x="6984748" y="3008136"/>
            <a:ext cx="611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IVC</a:t>
            </a:r>
          </a:p>
        </p:txBody>
      </p:sp>
      <p:cxnSp>
        <p:nvCxnSpPr>
          <p:cNvPr id="39" name="Conector de Seta Reta 5">
            <a:extLst>
              <a:ext uri="{FF2B5EF4-FFF2-40B4-BE49-F238E27FC236}">
                <a16:creationId xmlns:a16="http://schemas.microsoft.com/office/drawing/2014/main" id="{545FC0E3-AE06-3446-B879-F6B7AC9D4C87}"/>
              </a:ext>
            </a:extLst>
          </p:cNvPr>
          <p:cNvCxnSpPr>
            <a:cxnSpLocks/>
          </p:cNvCxnSpPr>
          <p:nvPr/>
        </p:nvCxnSpPr>
        <p:spPr>
          <a:xfrm flipV="1">
            <a:off x="7357821" y="2528322"/>
            <a:ext cx="293667" cy="509326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ixaDeTexto 4">
            <a:extLst>
              <a:ext uri="{FF2B5EF4-FFF2-40B4-BE49-F238E27FC236}">
                <a16:creationId xmlns:a16="http://schemas.microsoft.com/office/drawing/2014/main" id="{9E1503CC-ACF2-E049-AE68-C8EE9B143EFE}"/>
              </a:ext>
            </a:extLst>
          </p:cNvPr>
          <p:cNvSpPr txBox="1"/>
          <p:nvPr/>
        </p:nvSpPr>
        <p:spPr>
          <a:xfrm>
            <a:off x="12915404" y="1206887"/>
            <a:ext cx="943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Liver</a:t>
            </a:r>
          </a:p>
        </p:txBody>
      </p:sp>
      <p:sp>
        <p:nvSpPr>
          <p:cNvPr id="31" name="CaixaDeTexto 18">
            <a:extLst>
              <a:ext uri="{FF2B5EF4-FFF2-40B4-BE49-F238E27FC236}">
                <a16:creationId xmlns:a16="http://schemas.microsoft.com/office/drawing/2014/main" id="{41BA94A6-EA06-E144-9704-7DBE7FE71E8D}"/>
              </a:ext>
            </a:extLst>
          </p:cNvPr>
          <p:cNvSpPr txBox="1"/>
          <p:nvPr/>
        </p:nvSpPr>
        <p:spPr>
          <a:xfrm>
            <a:off x="2082928" y="2068094"/>
            <a:ext cx="1371965" cy="369332"/>
          </a:xfrm>
          <a:prstGeom prst="rect">
            <a:avLst/>
          </a:prstGeom>
          <a:solidFill>
            <a:schemeClr val="bg2">
              <a:lumMod val="25000"/>
            </a:schemeClr>
          </a:solidFill>
          <a:ln>
            <a:noFill/>
          </a:ln>
          <a:effectLst>
            <a:softEdge rad="1270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Pleural line</a:t>
            </a:r>
          </a:p>
        </p:txBody>
      </p:sp>
      <p:pic>
        <p:nvPicPr>
          <p:cNvPr id="47" name="Mídia Online 15" descr="12.42.59 horas __[0000341].mp4">
            <a:hlinkClick r:id="" action="ppaction://media"/>
            <a:extLst>
              <a:ext uri="{FF2B5EF4-FFF2-40B4-BE49-F238E27FC236}">
                <a16:creationId xmlns:a16="http://schemas.microsoft.com/office/drawing/2014/main" id="{F47A09A8-142D-8F4F-99A3-1A1949EBD1F7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8"/>
          <a:srcRect l="10945" t="6006" r="7836" b="17165"/>
          <a:stretch/>
        </p:blipFill>
        <p:spPr>
          <a:xfrm>
            <a:off x="111755" y="1619747"/>
            <a:ext cx="5284769" cy="4412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56913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4000" fill="hold"/>
                                        <p:tgtEl>
                                          <p:spTgt spid="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2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4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24"/>
                </p:tgtEl>
              </p:cMediaNode>
            </p:video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33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4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7"/>
                  </p:tgtEl>
                </p:cond>
              </p:nextCondLst>
            </p:seq>
            <p:video>
              <p:cMediaNode vol="80000">
                <p:cTn id="23" fill="hold" display="0">
                  <p:stCondLst>
                    <p:cond delay="indefinite"/>
                  </p:stCondLst>
                </p:cTn>
                <p:tgtEl>
                  <p:spTgt spid="4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6</TotalTime>
  <Words>33</Words>
  <Application>Microsoft Macintosh PowerPoint</Application>
  <PresentationFormat>Widescreen</PresentationFormat>
  <Paragraphs>17</Paragraphs>
  <Slides>1</Slides>
  <Notes>0</Notes>
  <HiddenSlides>0</HiddenSlides>
  <MMClips>2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hel Pordeus</dc:creator>
  <cp:lastModifiedBy>Rogerio Passos</cp:lastModifiedBy>
  <cp:revision>44</cp:revision>
  <dcterms:created xsi:type="dcterms:W3CDTF">2019-06-26T13:56:10Z</dcterms:created>
  <dcterms:modified xsi:type="dcterms:W3CDTF">2019-06-30T15:13:00Z</dcterms:modified>
</cp:coreProperties>
</file>